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412"/>
    <p:restoredTop sz="94564"/>
  </p:normalViewPr>
  <p:slideViewPr>
    <p:cSldViewPr snapToGrid="0" snapToObjects="1">
      <p:cViewPr varScale="1">
        <p:scale>
          <a:sx n="110" d="100"/>
          <a:sy n="110" d="100"/>
        </p:scale>
        <p:origin x="124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1C47FCC-A7DE-C54A-AF25-CF3134A986F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AE7335D1-9E70-0F40-8D7A-5846EAE0A26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EE7B809-7739-2041-ABA9-A6904F399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B7757A54-BC13-414D-8EE1-7BF7D104E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AFCF5D12-1CCC-BD4C-8210-4124CE6CC8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52045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41008995-ACAF-0946-AD65-4CE39C0BC7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0488A24C-E8CB-B040-AA5D-806F652E39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24A3198-AF85-6A48-BD97-04AF11696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C9384A95-3E38-634E-B52B-B6724BCFE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56465BA2-750C-1741-B28D-3AF19FE8A7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5159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1B74A11C-5EAD-384B-A797-CF6C3FC46D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BCC255D-C3D0-4B48-9811-29E6A0E1AB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F087BCE-BC84-8A4B-A6DD-15DA3A7EA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0315A85-6106-0C47-BB9B-CB1C66D27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171A8F-7A7B-E844-9679-7577E733C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1184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C211D9F-F5A1-7042-8E40-A09644020C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4480A747-1346-9A49-8CBF-135E486DD6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0431BFC2-859F-1548-8F03-2E015A16D3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9BA5BB7D-B8DC-604E-A60B-64B232C6BF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D689A912-A922-4A41-B698-98CAB56AD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3600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158ABA-C837-7645-81F3-E22661BB46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1A94E275-C56D-114A-973C-4B146AE16C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371FC319-B4C7-C540-9A64-006870F32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F7601ED-9DB0-F74A-B8A5-4DDD44A655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4AFFA59A-9C30-4A4B-AB32-E5A44E5AD1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84920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36ED1D9D-1F13-7948-9876-A23D68E43D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1F42A0A5-9A38-5845-8A12-BD65F65912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2014C03D-1629-774A-8077-08A08A9EF0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AB58E07-2FEA-2A40-ADFD-E9B12B471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472D9183-631D-7746-83B7-606309008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08906376-8AEB-AF46-A0F7-89B6A08E6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8080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E2A39C2-238F-5F4A-89CE-D2FC66BC00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9FD09BB6-60CB-A94E-96C5-91A64B38E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B8C6C03C-8CD1-6745-A502-D457C47E0E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6AA6C744-41E5-6146-BEBD-28F01027415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84BD8341-81E2-154C-9A40-E9F5E2055AD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02EADBF0-605E-2242-8437-77C2770D0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897B657F-7620-314C-94A0-0644E7FA0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5476E10A-C084-5A44-8CE6-8BA554AD4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22637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D9BC954-A6D5-4D4D-A357-3BC169A3EF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C5A5F159-5A9B-0742-9BA5-346A8EFF2B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EA834B68-E640-AA43-8D8A-8AA7BDA00D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6EB35191-87D9-C947-AAA2-7F38B9D766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57162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52860CFD-2CAE-514D-A399-5060F78FE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B51CB7B5-4807-4045-9E29-469425F39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445DFEF4-31E9-EF4C-8A54-2A7E38C14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7684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548C810C-9DFA-104C-8724-BC1B250556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5961EEE8-83FB-4940-BC3D-85AEC4914A7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5DB4D2E8-AF5C-2541-9208-2C51333DD8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7E9E150B-D3DF-9F4E-B6FB-9A8D2BD9CF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67CB1BD0-B1C2-844B-882F-CA2A1C5443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C522ED37-4F7C-8748-B605-C66B9D08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449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58696F9-A462-7B44-AB22-FA5F96AEB6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FD8D893F-F9F7-D64D-9627-711FD95FAC9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431A3F29-4BD5-8C4E-AD6B-C3D3195147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EEB28BA0-189F-CE4B-A0AB-327D0862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E3FCC168-F240-2343-9B8F-E39D54BFB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9868A88-B99D-2742-A011-FF14528AEF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5648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9BEB9B36-CA2C-8B46-91F3-5CCF05EF52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F77A482A-3857-8046-8B6A-FCB5325058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AF433CD6-F44C-094C-A03F-9BE1DF0733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AC7CE-8A88-364C-B00A-8E138C27736F}" type="datetimeFigureOut">
              <a:rPr lang="fr-FR" smtClean="0"/>
              <a:t>10/01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311BA33E-3BD6-BC40-BAE0-7AB6FA3AA6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9F73945D-303E-4B43-8388-09D2C93541D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D58DF-7C6B-0440-9EEF-F1F87F28B54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7161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xmlns="" id="{74567384-921D-6842-A777-8A8F51286A8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0149473"/>
              </p:ext>
            </p:extLst>
          </p:nvPr>
        </p:nvGraphicFramePr>
        <p:xfrm>
          <a:off x="3912055" y="190199"/>
          <a:ext cx="7676147" cy="650202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450852">
                  <a:extLst>
                    <a:ext uri="{9D8B030D-6E8A-4147-A177-3AD203B41FA5}">
                      <a16:colId xmlns:a16="http://schemas.microsoft.com/office/drawing/2014/main" xmlns="" val="3725960991"/>
                    </a:ext>
                  </a:extLst>
                </a:gridCol>
                <a:gridCol w="1969497">
                  <a:extLst>
                    <a:ext uri="{9D8B030D-6E8A-4147-A177-3AD203B41FA5}">
                      <a16:colId xmlns:a16="http://schemas.microsoft.com/office/drawing/2014/main" xmlns="" val="590449635"/>
                    </a:ext>
                  </a:extLst>
                </a:gridCol>
                <a:gridCol w="1851001">
                  <a:extLst>
                    <a:ext uri="{9D8B030D-6E8A-4147-A177-3AD203B41FA5}">
                      <a16:colId xmlns:a16="http://schemas.microsoft.com/office/drawing/2014/main" xmlns="" val="376190061"/>
                    </a:ext>
                  </a:extLst>
                </a:gridCol>
                <a:gridCol w="1404797">
                  <a:extLst>
                    <a:ext uri="{9D8B030D-6E8A-4147-A177-3AD203B41FA5}">
                      <a16:colId xmlns:a16="http://schemas.microsoft.com/office/drawing/2014/main" xmlns="" val="2132101415"/>
                    </a:ext>
                  </a:extLst>
                </a:gridCol>
              </a:tblGrid>
              <a:tr h="26832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Patients’ Characteristics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Vitamin C &lt; 5 µ</a:t>
                      </a:r>
                      <a:r>
                        <a:rPr lang="en-US" sz="100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mol</a:t>
                      </a: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/L</a:t>
                      </a:r>
                      <a:endParaRPr lang="fr-FR" sz="1000" dirty="0">
                        <a:solidFill>
                          <a:sysClr val="windowText" lastClr="000000"/>
                        </a:solidFill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Vitamin C </a:t>
                      </a: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</a:t>
                      </a: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 5 µ</a:t>
                      </a:r>
                      <a:r>
                        <a:rPr lang="en-US" sz="100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mol</a:t>
                      </a: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/L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P value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76141748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Age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68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9-76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 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70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9-76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20"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28221601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Body mass index (kg/m2)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4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0-28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0-2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7339154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Male gender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9 (7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0 (8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40265588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SAPS 2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68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8-73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65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7-98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09928204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SOFA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8-1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 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2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9-1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995813956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i="1" dirty="0">
                          <a:solidFill>
                            <a:sysClr val="windowText" lastClr="000000"/>
                          </a:solidFill>
                          <a:effectLst/>
                        </a:rPr>
                        <a:t>Comorbidities</a:t>
                      </a:r>
                      <a:endParaRPr lang="fr-FR" sz="1000" i="1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518301372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Diabetes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3 (2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3 (2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139099763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Hypertension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 (42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6 (50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76944736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Cardiovascular disease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4 (34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4 (34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4611451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Smokers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 (8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4 (34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8024825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Cirrhosis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 (16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800677538"/>
                  </a:ext>
                </a:extLst>
              </a:tr>
              <a:tr h="26832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Cancer/hematologic malignancies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3 (2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 (16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085743828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i="1" dirty="0">
                          <a:solidFill>
                            <a:sysClr val="windowText" lastClr="000000"/>
                          </a:solidFill>
                          <a:effectLst/>
                        </a:rPr>
                        <a:t>Septic shock sources</a:t>
                      </a:r>
                      <a:endParaRPr lang="fr-FR" sz="1000" i="1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16301386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Lung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4 (34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7 (58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94886521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Abdominal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3 (2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4 (34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738405455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Urinary tract infection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3 (2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0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26016018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Catheters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 (9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0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560816206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Others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 (9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 (9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806332226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i="1" dirty="0">
                          <a:solidFill>
                            <a:sysClr val="windowText" lastClr="000000"/>
                          </a:solidFill>
                          <a:effectLst/>
                        </a:rPr>
                        <a:t>Organ support therapy</a:t>
                      </a:r>
                      <a:endParaRPr lang="fr-FR" sz="1000" i="1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367403737"/>
                  </a:ext>
                </a:extLst>
              </a:tr>
              <a:tr h="80228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Mechanical ventilation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6 (50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0 (85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17783436"/>
                  </a:ext>
                </a:extLst>
              </a:tr>
              <a:tr h="15431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Vasopressor dose (µg/kg/min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6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2-0.7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.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4-1.4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06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44968887"/>
                  </a:ext>
                </a:extLst>
              </a:tr>
              <a:tr h="216737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Crystalloid prior to vitamin C infusion (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.0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.1- 2.9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.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.2- 2.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66966224"/>
                  </a:ext>
                </a:extLst>
              </a:tr>
              <a:tr h="162642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i="1" dirty="0">
                          <a:solidFill>
                            <a:sysClr val="windowText" lastClr="000000"/>
                          </a:solidFill>
                          <a:effectLst/>
                        </a:rPr>
                        <a:t>Biological parameters at inclusion</a:t>
                      </a:r>
                      <a:endParaRPr lang="fr-FR" sz="1000" i="1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042137536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Leucocytes (Giga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6-13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9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-36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6131875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Hemoglobin (g/</a:t>
                      </a:r>
                      <a:r>
                        <a:rPr lang="en-US" sz="1000" b="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dL</a:t>
                      </a: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7-12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8-12.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5939777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Platelets (Giga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59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05-267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47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62-347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4112387504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Serum creatinine (µ</a:t>
                      </a:r>
                      <a:r>
                        <a:rPr lang="en-US" sz="1000" b="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mol</a:t>
                      </a: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92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75-116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83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06-230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0.0017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51132835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Bicarbonate (mmol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21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7-24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22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7-27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19500647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Arterial lactate (mmol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4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3.1-5.3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3.4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.7-6.3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30465179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>
                          <a:solidFill>
                            <a:sysClr val="windowText" lastClr="000000"/>
                          </a:solidFill>
                          <a:effectLst/>
                        </a:rPr>
                        <a:t>Protidemia (g/L)</a:t>
                      </a:r>
                      <a:endParaRPr lang="fr-FR" sz="1000" b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52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45-60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58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52-66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1531377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Serum albumin (g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26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9-3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24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2-30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28011507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Vitamin C (µ</a:t>
                      </a:r>
                      <a:r>
                        <a:rPr lang="en-US" sz="1000" b="0" dirty="0" err="1">
                          <a:solidFill>
                            <a:sysClr val="windowText" lastClr="000000"/>
                          </a:solidFill>
                          <a:effectLst/>
                        </a:rPr>
                        <a:t>mol</a:t>
                      </a: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/L)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2.2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7-3.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6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8.5-32.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&lt;0.0001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38797906"/>
                  </a:ext>
                </a:extLst>
              </a:tr>
              <a:tr h="40248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Time between hospitalization and ICU admission (days)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18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2-39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2 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1-5</a:t>
                      </a: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en-US" sz="1000">
                          <a:solidFill>
                            <a:sysClr val="windowText" lastClr="000000"/>
                          </a:solidFill>
                          <a:effectLst/>
                        </a:rPr>
                        <a:t>0.03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8475283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i="1" dirty="0">
                          <a:solidFill>
                            <a:sysClr val="windowText" lastClr="000000"/>
                          </a:solidFill>
                          <a:effectLst/>
                        </a:rPr>
                        <a:t>Outcomes</a:t>
                      </a:r>
                      <a:endParaRPr lang="fr-FR" sz="1000" i="1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 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35993193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In-ICU mortality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3 (25)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6 (50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</a:p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NS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9159840"/>
                  </a:ext>
                </a:extLst>
              </a:tr>
              <a:tr h="134161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1000" b="0" dirty="0">
                          <a:solidFill>
                            <a:sysClr val="windowText" lastClr="000000"/>
                          </a:solidFill>
                          <a:effectLst/>
                        </a:rPr>
                        <a:t>In-hospital mortality</a:t>
                      </a:r>
                      <a:endParaRPr lang="fr-FR" sz="1000" b="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ysClr val="windowText" lastClr="000000"/>
                          </a:solidFill>
                          <a:effectLst/>
                        </a:rPr>
                        <a:t>6 (50)</a:t>
                      </a:r>
                      <a:endParaRPr lang="fr-FR" sz="100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ysClr val="windowText" lastClr="000000"/>
                          </a:solidFill>
                          <a:effectLst/>
                        </a:rPr>
                        <a:t>7 (60)</a:t>
                      </a:r>
                      <a:endParaRPr lang="fr-FR" sz="1000" dirty="0">
                        <a:solidFill>
                          <a:sysClr val="windowText" lastClr="000000"/>
                        </a:solidFill>
                        <a:effectLst/>
                        <a:latin typeface="Calibri" panose="020F0502020204030204" pitchFamily="34" charset="0"/>
                        <a:ea typeface="DengXian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37686" marR="37686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368876839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4391AB3D-5C22-504F-8497-986BCF2E25F4}"/>
              </a:ext>
            </a:extLst>
          </p:cNvPr>
          <p:cNvSpPr txBox="1"/>
          <p:nvPr/>
        </p:nvSpPr>
        <p:spPr>
          <a:xfrm>
            <a:off x="126459" y="5676562"/>
            <a:ext cx="354086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3. </a:t>
            </a:r>
            <a:r>
              <a:rPr lang="en-US" sz="1200" dirty="0"/>
              <a:t>General characteristics of patients according to plasma levels of Vitamin C. SAPS 2, Simplified Acute Physiology Score 2, SOFA, Sequential Organ Failure Assessment.</a:t>
            </a:r>
            <a:endParaRPr lang="fr-FR" sz="1200" dirty="0"/>
          </a:p>
          <a:p>
            <a:endParaRPr lang="fr-FR" sz="1200" dirty="0"/>
          </a:p>
        </p:txBody>
      </p:sp>
    </p:spTree>
    <p:extLst>
      <p:ext uri="{BB962C8B-B14F-4D97-AF65-F5344CB8AC3E}">
        <p14:creationId xmlns:p14="http://schemas.microsoft.com/office/powerpoint/2010/main" val="300022731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416</Words>
  <Application>Microsoft Office PowerPoint</Application>
  <PresentationFormat>Widescreen</PresentationFormat>
  <Paragraphs>1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DengXian</vt:lpstr>
      <vt:lpstr>Symbol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Femina P.</cp:lastModifiedBy>
  <cp:revision>16</cp:revision>
  <dcterms:created xsi:type="dcterms:W3CDTF">2021-09-29T14:29:35Z</dcterms:created>
  <dcterms:modified xsi:type="dcterms:W3CDTF">2022-01-10T12:08:17Z</dcterms:modified>
</cp:coreProperties>
</file>